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3gp" ContentType="video/3gpp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  <p:sldId id="26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2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6197"/>
  </p:normalViewPr>
  <p:slideViewPr>
    <p:cSldViewPr snapToGrid="0" snapToObjects="1">
      <p:cViewPr varScale="1">
        <p:scale>
          <a:sx n="89" d="100"/>
          <a:sy n="89" d="100"/>
        </p:scale>
        <p:origin x="43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48DB446-D7F4-4548-9521-EF3901D7A7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8E1E028B-5582-D84D-ABCE-F04BA57D95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B1B044F-9A33-574A-90D7-0536B7EF3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80DA22C-B824-EB44-93EF-1CDE6E1EF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1E77056-7DD8-C040-BB61-C16DBB5A8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81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7E062A2-1111-8B47-9058-1C23A7C830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B6C2E0A-1EDB-8049-ADAD-C1A30710F8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FEB2C5B-6B36-0C40-A182-6E7575D35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255920E-22AC-4746-BC37-E1637C5C5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667755E-62CF-ED46-A114-249AFC34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053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BCB81BB-4CC2-794E-B25A-497E8D8C3E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733C564-B805-6541-B2D9-E0C6CFEEBE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83C064B-1804-1F49-96DA-F852EBE95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363D7E7-607A-324C-9D3C-6C76A70D3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F7C22EC-5F01-C149-8DA6-FCE978CC2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827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37CA961-C2C6-1F49-8767-280584CB0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463C8CD-A388-9C49-AB84-3FED4FC466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6991C8F-0B57-5849-A182-88AB12D83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8FFBF20-8CD2-5F42-A432-60B755C14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3D1D2CB-B663-3A4F-A925-96D6F8AB3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796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9582EDD-F251-F24A-B1B7-3687CA8C6B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4BD0CC6-D4A7-4E41-B912-B4FBB73E1F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5ECEE88-03CD-F44B-826B-FC8C6D59C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1441A58-F207-1C4F-97C5-DAD7FCAD8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EE077B6-21B3-DC4F-9093-35B7BCA55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64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D3BD3A5-99AD-5E4A-8B9C-747FB8FC64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9C1E8FE-A5E3-0745-A16D-3D538D9C84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4264C86-AEA5-D243-9184-35BA797261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6CA0092-A02A-2D4A-BBB2-2AC323C3E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6212C87-E745-CA45-8752-4D234D06D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FDF8050-98FE-E34A-B11F-EB2A3126B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40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6F5826E-2273-B94D-8BDC-2306F3D0F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5D8E38E-A2C2-C04C-B1BA-5CAE7456A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6E048D3-C25A-1C4B-88DD-27F4C14D7B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7232149-2DDF-6740-828A-9055399938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361EA41-478D-6648-8AF6-F565EC08F5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739C5D88-5C71-7342-B71F-6D3E43D45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F6C57B6-85B4-F348-BEFC-E29539C06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042BD91-C8D4-FD41-BBE6-30165F82F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74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F073981-BB61-8C45-B52A-67DA4F90E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69CDACF-7441-B34A-8B12-8A5ECAC22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50C9B06-A113-F145-89B2-DE0E61395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3A0399E-BD3E-C147-A776-64ADE669E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15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1B5D4BF-4829-6743-90BA-FC71B7AB7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8CA6E8E-8F4C-D740-8E83-1BC55026B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1469E88-7323-7348-8822-4EA394EDF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20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F8195A7-B82E-F642-BFF6-3F4E2CB1C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D9C1DFF-DB7D-7544-868D-1D193A04D4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7159F4E-CBF3-B249-A935-E7AD780A56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0CC019A-C6EE-4346-8C2B-3AE0FB631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DAD5B3D-E163-994A-AEA2-3AC243080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401C51D-910B-4D4D-9528-F69D6D27C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853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A57A1C7-83A7-8D4F-AD7C-7F0F404D0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44C0FA72-B231-E145-B734-87E27CA7B9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DE042A4-DC0B-764B-920B-57214230BA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A38C15B-421B-D345-83CC-33C03A066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FD9C93A-1629-DC46-9CBE-C8903D030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1BEEA1C-EEA2-FA4E-AEBC-91A7E0862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58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C49CD58-E4F6-2243-A889-FE918669A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3B28BF1-086A-CD4D-AC76-C82240B2F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83CFDF-3AEC-3D4C-8D2C-43DD72BB8F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366F-2485-604A-8D28-877F646738DC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DC26963-3C1B-054A-8E50-EBC963C404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672C7FB-5858-9C48-A3FF-CDC26D63B9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00FC7C-DFCC-EA4B-B765-5EEC95CD8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195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ov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6" Type="http://schemas.openxmlformats.org/officeDocument/2006/relationships/video" Target="../media/media3.mov"/><Relationship Id="rId5" Type="http://schemas.microsoft.com/office/2007/relationships/media" Target="../media/media3.mov"/><Relationship Id="rId10" Type="http://schemas.openxmlformats.org/officeDocument/2006/relationships/image" Target="../media/image3.png"/><Relationship Id="rId4" Type="http://schemas.openxmlformats.org/officeDocument/2006/relationships/video" Target="../media/media2.mov"/><Relationship Id="rId9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5.3gp"/><Relationship Id="rId7" Type="http://schemas.openxmlformats.org/officeDocument/2006/relationships/image" Target="../media/image5.png"/><Relationship Id="rId2" Type="http://schemas.openxmlformats.org/officeDocument/2006/relationships/video" Target="../media/media4.3gp"/><Relationship Id="rId1" Type="http://schemas.microsoft.com/office/2007/relationships/media" Target="../media/media4.3gp"/><Relationship Id="rId6" Type="http://schemas.openxmlformats.org/officeDocument/2006/relationships/image" Target="../media/image4.png"/><Relationship Id="rId5" Type="http://schemas.openxmlformats.org/officeDocument/2006/relationships/slideLayout" Target="../slideLayouts/slideLayout5.xml"/><Relationship Id="rId4" Type="http://schemas.openxmlformats.org/officeDocument/2006/relationships/video" Target="../media/media5.3g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rol_A3_4" descr="Control_A3_4">
            <a:hlinkClick r:id="" action="ppaction://media"/>
            <a:extLst>
              <a:ext uri="{FF2B5EF4-FFF2-40B4-BE49-F238E27FC236}">
                <a16:creationId xmlns:a16="http://schemas.microsoft.com/office/drawing/2014/main" xmlns="" id="{C5EEF058-A7C9-3043-A8FE-AD5093A2B3A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67057" y="1640482"/>
            <a:ext cx="3854062" cy="2880000"/>
          </a:xfrm>
          <a:prstGeom prst="rect">
            <a:avLst/>
          </a:prstGeom>
        </p:spPr>
      </p:pic>
      <p:pic>
        <p:nvPicPr>
          <p:cNvPr id="11" name="Fe alone_B5'''" descr="Fe alone_B5'''">
            <a:hlinkClick r:id="" action="ppaction://media"/>
            <a:extLst>
              <a:ext uri="{FF2B5EF4-FFF2-40B4-BE49-F238E27FC236}">
                <a16:creationId xmlns:a16="http://schemas.microsoft.com/office/drawing/2014/main" xmlns="" id="{421387AB-5852-F04B-8A1A-555EBD301A58}"/>
              </a:ext>
            </a:extLst>
          </p:cNvPr>
          <p:cNvPicPr>
            <a:picLocks noGrp="1" noChangeAspect="1"/>
          </p:cNvPicPr>
          <p:nvPr>
            <p:ph sz="half" idx="2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160065" y="1640482"/>
            <a:ext cx="3854062" cy="2880000"/>
          </a:xfrm>
        </p:spPr>
      </p:pic>
      <p:pic>
        <p:nvPicPr>
          <p:cNvPr id="12" name="Fe+HS_B12" descr="Fe+HS_B12">
            <a:hlinkClick r:id="" action="ppaction://media"/>
            <a:extLst>
              <a:ext uri="{FF2B5EF4-FFF2-40B4-BE49-F238E27FC236}">
                <a16:creationId xmlns:a16="http://schemas.microsoft.com/office/drawing/2014/main" xmlns="" id="{C4339FCD-4D83-284D-9726-7217BDAFFCB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153073" y="1640482"/>
            <a:ext cx="3854062" cy="288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C78B5024-0E00-E745-80DE-861B6113BE6C}"/>
              </a:ext>
            </a:extLst>
          </p:cNvPr>
          <p:cNvSpPr txBox="1"/>
          <p:nvPr/>
        </p:nvSpPr>
        <p:spPr>
          <a:xfrm>
            <a:off x="1655217" y="1240117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4EEE2F6-6FF7-2944-B9B6-72E1116A71A6}"/>
              </a:ext>
            </a:extLst>
          </p:cNvPr>
          <p:cNvSpPr txBox="1"/>
          <p:nvPr/>
        </p:nvSpPr>
        <p:spPr>
          <a:xfrm>
            <a:off x="5764162" y="1240117"/>
            <a:ext cx="726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 Fe</a:t>
            </a:r>
            <a:r>
              <a:rPr lang="en-US" baseline="30000" dirty="0"/>
              <a:t>2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61C10DF-B9E7-D94A-B4DC-201EAE18FB5F}"/>
              </a:ext>
            </a:extLst>
          </p:cNvPr>
          <p:cNvSpPr txBox="1"/>
          <p:nvPr/>
        </p:nvSpPr>
        <p:spPr>
          <a:xfrm>
            <a:off x="9121023" y="1240117"/>
            <a:ext cx="11975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 Fe</a:t>
            </a:r>
            <a:r>
              <a:rPr lang="en-US" baseline="30000" dirty="0"/>
              <a:t>2+</a:t>
            </a:r>
            <a:r>
              <a:rPr lang="en-US" dirty="0"/>
              <a:t> + H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69DF276-46C4-4A4A-A5B7-40D96F75E5C2}"/>
              </a:ext>
            </a:extLst>
          </p:cNvPr>
          <p:cNvSpPr txBox="1"/>
          <p:nvPr/>
        </p:nvSpPr>
        <p:spPr>
          <a:xfrm>
            <a:off x="749300" y="330200"/>
            <a:ext cx="115884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solidFill>
                  <a:srgbClr val="2E2CFF"/>
                </a:solidFill>
              </a:rPr>
              <a:t>Supplementary </a:t>
            </a:r>
            <a:r>
              <a:rPr lang="en-US" sz="2000" dirty="0">
                <a:solidFill>
                  <a:srgbClr val="2E2CFF"/>
                </a:solidFill>
              </a:rPr>
              <a:t>Video </a:t>
            </a:r>
            <a:r>
              <a:rPr lang="en-US" sz="2000" dirty="0" smtClean="0">
                <a:solidFill>
                  <a:srgbClr val="2E2CFF"/>
                </a:solidFill>
              </a:rPr>
              <a:t>S1</a:t>
            </a:r>
            <a:r>
              <a:rPr lang="en-US" sz="2000" dirty="0">
                <a:solidFill>
                  <a:srgbClr val="2E2CFF"/>
                </a:solidFill>
              </a:rPr>
              <a:t>: The real time killing of neurons by iron is prevented by the presence of plant extrac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3A6DCBA-44D3-B947-A133-55CF70B6537D}"/>
              </a:ext>
            </a:extLst>
          </p:cNvPr>
          <p:cNvSpPr txBox="1"/>
          <p:nvPr/>
        </p:nvSpPr>
        <p:spPr>
          <a:xfrm>
            <a:off x="215900" y="949067"/>
            <a:ext cx="116967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314106D-0AC5-964B-8F20-D3CE4B506B22}"/>
              </a:ext>
            </a:extLst>
          </p:cNvPr>
          <p:cNvSpPr txBox="1"/>
          <p:nvPr/>
        </p:nvSpPr>
        <p:spPr>
          <a:xfrm>
            <a:off x="167057" y="5384800"/>
            <a:ext cx="1184007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sualization in real time of the killing of mouse neurons by iron and the protection by HS. All cells are labeled by the cell permeant Cell Tracker™ Red CMTPX dye. In control condition, few of the red cells incorporate SYTOX into their nuclei. In 50 µM FeSO4-exposed condition, the number of nuclei that turns green through SYTOX incorporation progressively increases from 8 to 20h. The presence of HS (100 µg/ml) prevents neurons from being compromised as determined by few red cells incorporating the SYTOX green dye. </a:t>
            </a:r>
          </a:p>
        </p:txBody>
      </p:sp>
    </p:spTree>
    <p:extLst>
      <p:ext uri="{BB962C8B-B14F-4D97-AF65-F5344CB8AC3E}">
        <p14:creationId xmlns:p14="http://schemas.microsoft.com/office/powerpoint/2010/main" val="30696729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70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5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6" fill="hold">
                      <p:stCondLst>
                        <p:cond delay="0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9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0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21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2" fill="hold">
                      <p:stCondLst>
                        <p:cond delay="0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5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6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27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8" fill="hold">
                      <p:stCondLst>
                        <p:cond delay="0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1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32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6175D424-56CF-4CD0-A4E5-5DC6EB330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249363"/>
            <a:ext cx="5157787" cy="823912"/>
          </a:xfrm>
        </p:spPr>
        <p:txBody>
          <a:bodyPr/>
          <a:lstStyle/>
          <a:p>
            <a:pPr algn="ctr"/>
            <a:r>
              <a:rPr lang="en-US" dirty="0"/>
              <a:t>EAE + Vehicle</a:t>
            </a:r>
            <a:endParaRPr lang="en-CA" dirty="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xmlns="" id="{6BD2C3AA-8E6A-484D-BFF8-63462463DA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223963"/>
            <a:ext cx="5183188" cy="823912"/>
          </a:xfrm>
        </p:spPr>
        <p:txBody>
          <a:bodyPr/>
          <a:lstStyle/>
          <a:p>
            <a:pPr algn="ctr"/>
            <a:r>
              <a:rPr lang="en-US" dirty="0"/>
              <a:t>EAE + HS</a:t>
            </a:r>
            <a:endParaRPr lang="en-CA" dirty="0"/>
          </a:p>
        </p:txBody>
      </p:sp>
      <p:pic>
        <p:nvPicPr>
          <p:cNvPr id="6" name="1 Vehicle-EAE av score">
            <a:hlinkClick r:id="" action="ppaction://media"/>
            <a:extLst>
              <a:ext uri="{FF2B5EF4-FFF2-40B4-BE49-F238E27FC236}">
                <a16:creationId xmlns:a16="http://schemas.microsoft.com/office/drawing/2014/main" xmlns="" id="{557109F1-EB73-4D7E-80D8-1D95151D25A7}"/>
              </a:ext>
            </a:extLst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7032" r="26859"/>
          <a:stretch/>
        </p:blipFill>
        <p:spPr>
          <a:xfrm rot="16200000">
            <a:off x="1701112" y="1668406"/>
            <a:ext cx="3205744" cy="4669532"/>
          </a:xfrm>
        </p:spPr>
      </p:pic>
      <p:pic>
        <p:nvPicPr>
          <p:cNvPr id="9" name="EAE and HS av score">
            <a:hlinkClick r:id="" action="ppaction://media"/>
            <a:extLst>
              <a:ext uri="{FF2B5EF4-FFF2-40B4-BE49-F238E27FC236}">
                <a16:creationId xmlns:a16="http://schemas.microsoft.com/office/drawing/2014/main" xmlns="" id="{A9CE344E-FF97-47B4-81E7-67977E844C5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/>
          <a:srcRect t="15972" b="15608"/>
          <a:stretch/>
        </p:blipFill>
        <p:spPr>
          <a:xfrm>
            <a:off x="5722534" y="2392863"/>
            <a:ext cx="5732865" cy="320902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5BF74003-0F9F-CF4D-AC63-596280C2128E}"/>
              </a:ext>
            </a:extLst>
          </p:cNvPr>
          <p:cNvSpPr txBox="1"/>
          <p:nvPr/>
        </p:nvSpPr>
        <p:spPr>
          <a:xfrm>
            <a:off x="3033164" y="152400"/>
            <a:ext cx="605435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/>
              <a:t>Supplementary Video </a:t>
            </a:r>
            <a:r>
              <a:rPr lang="en-US" sz="2400" dirty="0" smtClean="0"/>
              <a:t>S2</a:t>
            </a:r>
            <a:r>
              <a:rPr lang="en-US" sz="2400" dirty="0"/>
              <a:t>: Disability in EAE mice</a:t>
            </a:r>
          </a:p>
          <a:p>
            <a:pPr algn="ctr"/>
            <a:r>
              <a:rPr lang="en-US" sz="2400" dirty="0"/>
              <a:t>treated with vehicle versus H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9928A08-91CC-EF4D-B30B-AB055B29DDF4}"/>
              </a:ext>
            </a:extLst>
          </p:cNvPr>
          <p:cNvSpPr txBox="1"/>
          <p:nvPr/>
        </p:nvSpPr>
        <p:spPr>
          <a:xfrm>
            <a:off x="546100" y="6210300"/>
            <a:ext cx="1167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resentative disability in EAE-afflicted mice treated with HS or EAE, and recorded just before sacrifice at day 24. </a:t>
            </a:r>
          </a:p>
        </p:txBody>
      </p:sp>
    </p:spTree>
    <p:extLst>
      <p:ext uri="{BB962C8B-B14F-4D97-AF65-F5344CB8AC3E}">
        <p14:creationId xmlns:p14="http://schemas.microsoft.com/office/powerpoint/2010/main" val="35213303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48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266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164</Words>
  <Application>Microsoft Office PowerPoint</Application>
  <PresentationFormat>Widescreen</PresentationFormat>
  <Paragraphs>10</Paragraphs>
  <Slides>2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ffect of HS 01 on Fe2+ induced neurotoxicity (mouse fetal neurons)</dc:title>
  <dc:creator>Manoj Kumar Mishra</dc:creator>
  <cp:lastModifiedBy>MDPI</cp:lastModifiedBy>
  <cp:revision>16</cp:revision>
  <dcterms:created xsi:type="dcterms:W3CDTF">2021-09-21T17:12:43Z</dcterms:created>
  <dcterms:modified xsi:type="dcterms:W3CDTF">2022-01-27T10:57:50Z</dcterms:modified>
</cp:coreProperties>
</file>